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60" r:id="rId5"/>
    <p:sldId id="259" r:id="rId6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8980451-A357-4A60-A162-EB00D5DF33CE}" v="4" dt="2023-07-10T14:50:18.12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78" autoAdjust="0"/>
    <p:restoredTop sz="94660"/>
  </p:normalViewPr>
  <p:slideViewPr>
    <p:cSldViewPr snapToGrid="0">
      <p:cViewPr>
        <p:scale>
          <a:sx n="100" d="100"/>
          <a:sy n="100" d="100"/>
        </p:scale>
        <p:origin x="2382" y="-5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microsoft.com/office/2015/10/relationships/revisionInfo" Target="revisionInfo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6E9C90-0E33-44CD-9BE8-B973ED1DB3E7}" type="datetimeFigureOut">
              <a:rPr lang="en-US" smtClean="0"/>
              <a:t>7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36BD9-C1D5-4B9F-86C5-85550EE333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26236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6E9C90-0E33-44CD-9BE8-B973ED1DB3E7}" type="datetimeFigureOut">
              <a:rPr lang="en-US" smtClean="0"/>
              <a:t>7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36BD9-C1D5-4B9F-86C5-85550EE333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72428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6E9C90-0E33-44CD-9BE8-B973ED1DB3E7}" type="datetimeFigureOut">
              <a:rPr lang="en-US" smtClean="0"/>
              <a:t>7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36BD9-C1D5-4B9F-86C5-85550EE333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48128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6E9C90-0E33-44CD-9BE8-B973ED1DB3E7}" type="datetimeFigureOut">
              <a:rPr lang="en-US" smtClean="0"/>
              <a:t>7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36BD9-C1D5-4B9F-86C5-85550EE333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15300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6E9C90-0E33-44CD-9BE8-B973ED1DB3E7}" type="datetimeFigureOut">
              <a:rPr lang="en-US" smtClean="0"/>
              <a:t>7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36BD9-C1D5-4B9F-86C5-85550EE333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0812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6E9C90-0E33-44CD-9BE8-B973ED1DB3E7}" type="datetimeFigureOut">
              <a:rPr lang="en-US" smtClean="0"/>
              <a:t>7/1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36BD9-C1D5-4B9F-86C5-85550EE333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18586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6E9C90-0E33-44CD-9BE8-B973ED1DB3E7}" type="datetimeFigureOut">
              <a:rPr lang="en-US" smtClean="0"/>
              <a:t>7/1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36BD9-C1D5-4B9F-86C5-85550EE333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82546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6E9C90-0E33-44CD-9BE8-B973ED1DB3E7}" type="datetimeFigureOut">
              <a:rPr lang="en-US" smtClean="0"/>
              <a:t>7/1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36BD9-C1D5-4B9F-86C5-85550EE333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9800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6E9C90-0E33-44CD-9BE8-B973ED1DB3E7}" type="datetimeFigureOut">
              <a:rPr lang="en-US" smtClean="0"/>
              <a:t>7/1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36BD9-C1D5-4B9F-86C5-85550EE333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6539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6E9C90-0E33-44CD-9BE8-B973ED1DB3E7}" type="datetimeFigureOut">
              <a:rPr lang="en-US" smtClean="0"/>
              <a:t>7/1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36BD9-C1D5-4B9F-86C5-85550EE333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86593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6E9C90-0E33-44CD-9BE8-B973ED1DB3E7}" type="datetimeFigureOut">
              <a:rPr lang="en-US" smtClean="0"/>
              <a:t>7/1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36BD9-C1D5-4B9F-86C5-85550EE333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85656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6E9C90-0E33-44CD-9BE8-B973ED1DB3E7}" type="datetimeFigureOut">
              <a:rPr lang="en-US" smtClean="0"/>
              <a:t>7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736BD9-C1D5-4B9F-86C5-85550EE333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99380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"/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4A5E98B-B72A-88FC-BA8C-369EF3A97664}"/>
              </a:ext>
            </a:extLst>
          </p:cNvPr>
          <p:cNvSpPr txBox="1"/>
          <p:nvPr/>
        </p:nvSpPr>
        <p:spPr>
          <a:xfrm>
            <a:off x="477981" y="457200"/>
            <a:ext cx="23899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2</a:t>
            </a:r>
          </a:p>
        </p:txBody>
      </p:sp>
      <p:pic>
        <p:nvPicPr>
          <p:cNvPr id="6" name="Picture 5" descr="A picture containing monochrome, black and white, monochrome photography, white&#10;&#10;Description automatically generated">
            <a:extLst>
              <a:ext uri="{FF2B5EF4-FFF2-40B4-BE49-F238E27FC236}">
                <a16:creationId xmlns:a16="http://schemas.microsoft.com/office/drawing/2014/main" id="{D6CBE538-09D2-00FD-3681-A4D3C9D4D7D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364" y="2202102"/>
            <a:ext cx="4545869" cy="303057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350BDC2F-0C43-89B9-C637-6BC37A1020CC}"/>
              </a:ext>
            </a:extLst>
          </p:cNvPr>
          <p:cNvSpPr txBox="1"/>
          <p:nvPr/>
        </p:nvSpPr>
        <p:spPr>
          <a:xfrm>
            <a:off x="477981" y="1161411"/>
            <a:ext cx="23899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2B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386D428-01AF-66A5-56F1-6E1E1B60C5B4}"/>
              </a:ext>
            </a:extLst>
          </p:cNvPr>
          <p:cNvSpPr txBox="1"/>
          <p:nvPr/>
        </p:nvSpPr>
        <p:spPr>
          <a:xfrm>
            <a:off x="-428215" y="3381030"/>
            <a:ext cx="14615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 err="1"/>
              <a:t>RpoA</a:t>
            </a:r>
            <a:endParaRPr lang="en-US" sz="1200" dirty="0"/>
          </a:p>
          <a:p>
            <a:pPr algn="r"/>
            <a:r>
              <a:rPr lang="en-US" sz="1200" dirty="0"/>
              <a:t>VqmA-3XFLAG</a:t>
            </a:r>
          </a:p>
        </p:txBody>
      </p:sp>
      <p:pic>
        <p:nvPicPr>
          <p:cNvPr id="8" name="Picture 7" descr="A picture containing black and white, monochrome&#10;&#10;Description automatically generated with medium confidence">
            <a:extLst>
              <a:ext uri="{FF2B5EF4-FFF2-40B4-BE49-F238E27FC236}">
                <a16:creationId xmlns:a16="http://schemas.microsoft.com/office/drawing/2014/main" id="{E258F2E6-E646-E268-BC1E-9CFBC4235CA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2146" y="5904040"/>
            <a:ext cx="5463959" cy="364263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8F148263-1EF3-DB1B-E146-AEE78AB73BC1}"/>
              </a:ext>
            </a:extLst>
          </p:cNvPr>
          <p:cNvSpPr txBox="1"/>
          <p:nvPr/>
        </p:nvSpPr>
        <p:spPr>
          <a:xfrm>
            <a:off x="1162607" y="2533305"/>
            <a:ext cx="11639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13281A6-6115-F713-1481-74AA5CD0462E}"/>
              </a:ext>
            </a:extLst>
          </p:cNvPr>
          <p:cNvSpPr txBox="1"/>
          <p:nvPr/>
        </p:nvSpPr>
        <p:spPr>
          <a:xfrm>
            <a:off x="2322901" y="6510021"/>
            <a:ext cx="11639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DB786F1-54F2-E79F-D952-30AF85CE415B}"/>
              </a:ext>
            </a:extLst>
          </p:cNvPr>
          <p:cNvSpPr txBox="1"/>
          <p:nvPr/>
        </p:nvSpPr>
        <p:spPr>
          <a:xfrm>
            <a:off x="4146173" y="6510021"/>
            <a:ext cx="11639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94C0C86-E667-CF8F-E3A8-C95E9A0E696F}"/>
              </a:ext>
            </a:extLst>
          </p:cNvPr>
          <p:cNvSpPr txBox="1"/>
          <p:nvPr/>
        </p:nvSpPr>
        <p:spPr>
          <a:xfrm>
            <a:off x="2045337" y="2448384"/>
            <a:ext cx="11639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Rep 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3D76F12-0DA4-463F-0CBA-51EF2481887D}"/>
              </a:ext>
            </a:extLst>
          </p:cNvPr>
          <p:cNvSpPr txBox="1"/>
          <p:nvPr/>
        </p:nvSpPr>
        <p:spPr>
          <a:xfrm>
            <a:off x="2904149" y="6608251"/>
            <a:ext cx="11639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Rep 2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844FE2C-3604-6B3F-2DFE-CA6ABB340020}"/>
              </a:ext>
            </a:extLst>
          </p:cNvPr>
          <p:cNvSpPr txBox="1"/>
          <p:nvPr/>
        </p:nvSpPr>
        <p:spPr>
          <a:xfrm>
            <a:off x="4900233" y="6608251"/>
            <a:ext cx="11639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Rep 3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4D76AE7-A3D3-64A4-EBC7-A6DE8C400443}"/>
              </a:ext>
            </a:extLst>
          </p:cNvPr>
          <p:cNvSpPr txBox="1"/>
          <p:nvPr/>
        </p:nvSpPr>
        <p:spPr>
          <a:xfrm>
            <a:off x="635507" y="7625465"/>
            <a:ext cx="14615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 err="1"/>
              <a:t>RpoA</a:t>
            </a:r>
            <a:endParaRPr lang="en-US" sz="1200" dirty="0"/>
          </a:p>
          <a:p>
            <a:pPr algn="r"/>
            <a:r>
              <a:rPr lang="en-US" sz="1200" dirty="0"/>
              <a:t>VqmA-3XFLAG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109FE5AA-E67B-897A-4CDF-8F42EA0CE979}"/>
              </a:ext>
            </a:extLst>
          </p:cNvPr>
          <p:cNvSpPr/>
          <p:nvPr/>
        </p:nvSpPr>
        <p:spPr>
          <a:xfrm>
            <a:off x="1454866" y="3365835"/>
            <a:ext cx="2126797" cy="60727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DB963FEF-7EE7-1AA1-33C8-1E75DD44EFEE}"/>
              </a:ext>
            </a:extLst>
          </p:cNvPr>
          <p:cNvSpPr/>
          <p:nvPr/>
        </p:nvSpPr>
        <p:spPr>
          <a:xfrm>
            <a:off x="2524089" y="7568251"/>
            <a:ext cx="1757626" cy="60727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1E35E21B-CEB3-534F-D119-F7533DBEFC11}"/>
              </a:ext>
            </a:extLst>
          </p:cNvPr>
          <p:cNvSpPr/>
          <p:nvPr/>
        </p:nvSpPr>
        <p:spPr>
          <a:xfrm>
            <a:off x="4448043" y="7568251"/>
            <a:ext cx="1757626" cy="60727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" name="Picture 2" descr="A blurry image of a person's feet&#10;&#10;Description automatically generated">
            <a:extLst>
              <a:ext uri="{FF2B5EF4-FFF2-40B4-BE49-F238E27FC236}">
                <a16:creationId xmlns:a16="http://schemas.microsoft.com/office/drawing/2014/main" id="{6719C8FE-7837-3BA8-5132-457B8AE3046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06097" y="3450594"/>
            <a:ext cx="2311940" cy="46375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C2B7228B-0A30-2AC7-4B51-668F0676531C}"/>
              </a:ext>
            </a:extLst>
          </p:cNvPr>
          <p:cNvSpPr txBox="1"/>
          <p:nvPr/>
        </p:nvSpPr>
        <p:spPr>
          <a:xfrm>
            <a:off x="5232401" y="3111781"/>
            <a:ext cx="23119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Modified exposure (Rep 1 blot)</a:t>
            </a:r>
          </a:p>
        </p:txBody>
      </p:sp>
    </p:spTree>
    <p:extLst>
      <p:ext uri="{BB962C8B-B14F-4D97-AF65-F5344CB8AC3E}">
        <p14:creationId xmlns:p14="http://schemas.microsoft.com/office/powerpoint/2010/main" val="16787799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AAF4132-02E5-5EEA-7F33-63689BCCDC52}"/>
              </a:ext>
            </a:extLst>
          </p:cNvPr>
          <p:cNvSpPr txBox="1"/>
          <p:nvPr/>
        </p:nvSpPr>
        <p:spPr>
          <a:xfrm>
            <a:off x="569143" y="590260"/>
            <a:ext cx="23899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2D</a:t>
            </a:r>
          </a:p>
        </p:txBody>
      </p:sp>
      <p:pic>
        <p:nvPicPr>
          <p:cNvPr id="5" name="Picture 4" descr="A picture containing white, ice maker&#10;&#10;Description automatically generated">
            <a:extLst>
              <a:ext uri="{FF2B5EF4-FFF2-40B4-BE49-F238E27FC236}">
                <a16:creationId xmlns:a16="http://schemas.microsoft.com/office/drawing/2014/main" id="{F95477D8-171F-82E5-774C-708A99B03D3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9606" y="1363546"/>
            <a:ext cx="4953188" cy="330212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631604A9-3480-7E27-F955-C58367C62C9C}"/>
              </a:ext>
            </a:extLst>
          </p:cNvPr>
          <p:cNvSpPr/>
          <p:nvPr/>
        </p:nvSpPr>
        <p:spPr>
          <a:xfrm>
            <a:off x="2321991" y="2557734"/>
            <a:ext cx="1484828" cy="60727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0C49297E-A19A-43F4-03E0-DB48E28360CD}"/>
              </a:ext>
            </a:extLst>
          </p:cNvPr>
          <p:cNvSpPr/>
          <p:nvPr/>
        </p:nvSpPr>
        <p:spPr>
          <a:xfrm>
            <a:off x="3806819" y="2412124"/>
            <a:ext cx="1540329" cy="75288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9" name="Picture 8" descr="A picture containing black and white, white, monochrome, monochrome photography&#10;&#10;Description automatically generated">
            <a:extLst>
              <a:ext uri="{FF2B5EF4-FFF2-40B4-BE49-F238E27FC236}">
                <a16:creationId xmlns:a16="http://schemas.microsoft.com/office/drawing/2014/main" id="{26F66EDB-5F16-ED27-6061-1AFB34585BA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9606" y="5415443"/>
            <a:ext cx="5087083" cy="339138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578C7CDC-73FC-688D-4483-E4EEE7A14149}"/>
              </a:ext>
            </a:extLst>
          </p:cNvPr>
          <p:cNvSpPr/>
          <p:nvPr/>
        </p:nvSpPr>
        <p:spPr>
          <a:xfrm>
            <a:off x="2748913" y="6709687"/>
            <a:ext cx="1540329" cy="560473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E21A63C1-68A8-DC55-60E6-CE19C2B704A5}"/>
              </a:ext>
            </a:extLst>
          </p:cNvPr>
          <p:cNvSpPr/>
          <p:nvPr/>
        </p:nvSpPr>
        <p:spPr>
          <a:xfrm>
            <a:off x="4320268" y="6609634"/>
            <a:ext cx="1540329" cy="660526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19F6072-461B-B85A-D0DB-FF9EA611320E}"/>
              </a:ext>
            </a:extLst>
          </p:cNvPr>
          <p:cNvSpPr txBox="1"/>
          <p:nvPr/>
        </p:nvSpPr>
        <p:spPr>
          <a:xfrm>
            <a:off x="5347147" y="2630539"/>
            <a:ext cx="14615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RpoA</a:t>
            </a:r>
            <a:endParaRPr lang="en-US" sz="1200" dirty="0"/>
          </a:p>
          <a:p>
            <a:r>
              <a:rPr lang="en-US" sz="1200" dirty="0"/>
              <a:t>VqmA</a:t>
            </a:r>
            <a:r>
              <a:rPr lang="en-US" sz="1200" baseline="-25000" dirty="0"/>
              <a:t>RIMD</a:t>
            </a:r>
            <a:r>
              <a:rPr lang="en-US" sz="1200" dirty="0"/>
              <a:t>-3XFLAG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78AF44C-D9FF-2879-4D52-EB8356E3F80F}"/>
              </a:ext>
            </a:extLst>
          </p:cNvPr>
          <p:cNvSpPr txBox="1"/>
          <p:nvPr/>
        </p:nvSpPr>
        <p:spPr>
          <a:xfrm>
            <a:off x="881568" y="2605864"/>
            <a:ext cx="14615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 err="1"/>
              <a:t>RpoA</a:t>
            </a:r>
            <a:endParaRPr lang="en-US" sz="1200" dirty="0"/>
          </a:p>
          <a:p>
            <a:pPr algn="r"/>
            <a:r>
              <a:rPr lang="en-US" sz="1200" dirty="0"/>
              <a:t>VqmA</a:t>
            </a:r>
            <a:r>
              <a:rPr lang="en-US" sz="1200" baseline="-25000" dirty="0"/>
              <a:t>Vc</a:t>
            </a:r>
            <a:r>
              <a:rPr lang="en-US" sz="1200" dirty="0"/>
              <a:t>-3XFLAG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BE63524-DEF3-4687-459C-5CC89C0BD731}"/>
              </a:ext>
            </a:extLst>
          </p:cNvPr>
          <p:cNvSpPr txBox="1"/>
          <p:nvPr/>
        </p:nvSpPr>
        <p:spPr>
          <a:xfrm>
            <a:off x="5860597" y="6759090"/>
            <a:ext cx="14615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RpoA</a:t>
            </a:r>
            <a:endParaRPr lang="en-US" sz="1200" dirty="0"/>
          </a:p>
          <a:p>
            <a:r>
              <a:rPr lang="en-US" sz="1200" dirty="0"/>
              <a:t>VqmA</a:t>
            </a:r>
            <a:r>
              <a:rPr lang="en-US" sz="1200" baseline="-25000" dirty="0"/>
              <a:t>RIMD</a:t>
            </a:r>
            <a:r>
              <a:rPr lang="en-US" sz="1200" dirty="0"/>
              <a:t>-3XFLAG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28C4875-DF43-8167-6200-AFF59506034A}"/>
              </a:ext>
            </a:extLst>
          </p:cNvPr>
          <p:cNvSpPr txBox="1"/>
          <p:nvPr/>
        </p:nvSpPr>
        <p:spPr>
          <a:xfrm>
            <a:off x="1256312" y="6880304"/>
            <a:ext cx="14615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 err="1"/>
              <a:t>RpoA</a:t>
            </a:r>
            <a:endParaRPr lang="en-US" sz="1200" dirty="0"/>
          </a:p>
          <a:p>
            <a:pPr algn="r"/>
            <a:r>
              <a:rPr lang="en-US" sz="1200" dirty="0"/>
              <a:t>VqmA</a:t>
            </a:r>
            <a:r>
              <a:rPr lang="en-US" sz="1200" baseline="-25000" dirty="0"/>
              <a:t>Vc</a:t>
            </a:r>
            <a:r>
              <a:rPr lang="en-US" sz="1200" dirty="0"/>
              <a:t>-3XFLAG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08253EE-E019-F163-9A2B-E4D28D1E6478}"/>
              </a:ext>
            </a:extLst>
          </p:cNvPr>
          <p:cNvSpPr txBox="1"/>
          <p:nvPr/>
        </p:nvSpPr>
        <p:spPr>
          <a:xfrm>
            <a:off x="1256312" y="5701128"/>
            <a:ext cx="14615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/>
              <a:t>M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BC0DE9E-08F3-CFF8-7E45-2C5BC6E9AE6C}"/>
              </a:ext>
            </a:extLst>
          </p:cNvPr>
          <p:cNvSpPr txBox="1"/>
          <p:nvPr/>
        </p:nvSpPr>
        <p:spPr>
          <a:xfrm>
            <a:off x="4705631" y="5701128"/>
            <a:ext cx="14615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/>
              <a:t>M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AE92642-CC59-92CA-2711-BF7EAD7B5FEF}"/>
              </a:ext>
            </a:extLst>
          </p:cNvPr>
          <p:cNvSpPr txBox="1"/>
          <p:nvPr/>
        </p:nvSpPr>
        <p:spPr>
          <a:xfrm>
            <a:off x="860416" y="1739277"/>
            <a:ext cx="14615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/>
              <a:t>M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3227421-6DAA-0F92-16B5-856EFAE6A93A}"/>
              </a:ext>
            </a:extLst>
          </p:cNvPr>
          <p:cNvSpPr txBox="1"/>
          <p:nvPr/>
        </p:nvSpPr>
        <p:spPr>
          <a:xfrm>
            <a:off x="4149715" y="1739277"/>
            <a:ext cx="14615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/>
              <a:t>M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86A7E52-7814-C68D-F346-DAA79AC93BD1}"/>
              </a:ext>
            </a:extLst>
          </p:cNvPr>
          <p:cNvSpPr txBox="1"/>
          <p:nvPr/>
        </p:nvSpPr>
        <p:spPr>
          <a:xfrm>
            <a:off x="2985794" y="5516462"/>
            <a:ext cx="11639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Rep 2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CE61367-1FF8-C05B-7B90-346EE91F184A}"/>
              </a:ext>
            </a:extLst>
          </p:cNvPr>
          <p:cNvSpPr txBox="1"/>
          <p:nvPr/>
        </p:nvSpPr>
        <p:spPr>
          <a:xfrm>
            <a:off x="2653892" y="1538860"/>
            <a:ext cx="11639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Rep 1</a:t>
            </a:r>
          </a:p>
        </p:txBody>
      </p:sp>
    </p:spTree>
    <p:extLst>
      <p:ext uri="{BB962C8B-B14F-4D97-AF65-F5344CB8AC3E}">
        <p14:creationId xmlns:p14="http://schemas.microsoft.com/office/powerpoint/2010/main" val="37814520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A picture containing white, black and white, sketch, monochrome&#10;&#10;Description automatically generated">
            <a:extLst>
              <a:ext uri="{FF2B5EF4-FFF2-40B4-BE49-F238E27FC236}">
                <a16:creationId xmlns:a16="http://schemas.microsoft.com/office/drawing/2014/main" id="{54F86E6A-40D0-2847-0742-1D4373444C20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4987" y="2125360"/>
            <a:ext cx="6702425" cy="4468283"/>
          </a:xfrm>
          <a:ln>
            <a:solidFill>
              <a:schemeClr val="tx1"/>
            </a:solidFill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F7B6DD4-4DA9-C0C7-BB9B-17E17E8C97AB}"/>
              </a:ext>
            </a:extLst>
          </p:cNvPr>
          <p:cNvSpPr txBox="1"/>
          <p:nvPr/>
        </p:nvSpPr>
        <p:spPr>
          <a:xfrm>
            <a:off x="956951" y="1363110"/>
            <a:ext cx="23899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3D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253789D1-93C0-949C-40FD-3900513BE981}"/>
              </a:ext>
            </a:extLst>
          </p:cNvPr>
          <p:cNvSpPr/>
          <p:nvPr/>
        </p:nvSpPr>
        <p:spPr>
          <a:xfrm>
            <a:off x="1814202" y="3877542"/>
            <a:ext cx="1062347" cy="60419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0046BFBA-D0C8-988F-9756-041287497A1C}"/>
              </a:ext>
            </a:extLst>
          </p:cNvPr>
          <p:cNvSpPr/>
          <p:nvPr/>
        </p:nvSpPr>
        <p:spPr>
          <a:xfrm>
            <a:off x="3355025" y="3877542"/>
            <a:ext cx="1062347" cy="60419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ACCC9AEC-07D0-2635-038C-D7647DDEDA7B}"/>
              </a:ext>
            </a:extLst>
          </p:cNvPr>
          <p:cNvSpPr/>
          <p:nvPr/>
        </p:nvSpPr>
        <p:spPr>
          <a:xfrm>
            <a:off x="4895849" y="3877542"/>
            <a:ext cx="1062347" cy="60419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E293B2E-F036-E0F5-B51B-FB301620CD3E}"/>
              </a:ext>
            </a:extLst>
          </p:cNvPr>
          <p:cNvSpPr txBox="1"/>
          <p:nvPr/>
        </p:nvSpPr>
        <p:spPr>
          <a:xfrm>
            <a:off x="1430975" y="3311751"/>
            <a:ext cx="914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DBB4F0A-760F-9B57-3B04-58193C177D8C}"/>
              </a:ext>
            </a:extLst>
          </p:cNvPr>
          <p:cNvSpPr txBox="1"/>
          <p:nvPr/>
        </p:nvSpPr>
        <p:spPr>
          <a:xfrm>
            <a:off x="2923430" y="3311751"/>
            <a:ext cx="914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52101E7-4350-A975-FFCD-72D827B75638}"/>
              </a:ext>
            </a:extLst>
          </p:cNvPr>
          <p:cNvSpPr txBox="1"/>
          <p:nvPr/>
        </p:nvSpPr>
        <p:spPr>
          <a:xfrm>
            <a:off x="4512622" y="3311751"/>
            <a:ext cx="914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82CA560-AD6E-D683-4991-1D77BFEBCB4E}"/>
              </a:ext>
            </a:extLst>
          </p:cNvPr>
          <p:cNvSpPr txBox="1"/>
          <p:nvPr/>
        </p:nvSpPr>
        <p:spPr>
          <a:xfrm>
            <a:off x="2053788" y="3409981"/>
            <a:ext cx="914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Rep 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B552D51-960A-BFC5-1A8F-FDF6410B9DA8}"/>
              </a:ext>
            </a:extLst>
          </p:cNvPr>
          <p:cNvSpPr txBox="1"/>
          <p:nvPr/>
        </p:nvSpPr>
        <p:spPr>
          <a:xfrm>
            <a:off x="3479568" y="3409981"/>
            <a:ext cx="914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Rep 2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C282EB2-899B-7F24-A96B-5B026DB20823}"/>
              </a:ext>
            </a:extLst>
          </p:cNvPr>
          <p:cNvSpPr txBox="1"/>
          <p:nvPr/>
        </p:nvSpPr>
        <p:spPr>
          <a:xfrm>
            <a:off x="5043796" y="3409981"/>
            <a:ext cx="914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Rep 3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72A05CA-289E-7E47-AF90-051C57A5DEBE}"/>
              </a:ext>
            </a:extLst>
          </p:cNvPr>
          <p:cNvSpPr txBox="1"/>
          <p:nvPr/>
        </p:nvSpPr>
        <p:spPr>
          <a:xfrm>
            <a:off x="6015075" y="3948808"/>
            <a:ext cx="14615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LuxO-3XFLAG</a:t>
            </a:r>
          </a:p>
          <a:p>
            <a:r>
              <a:rPr lang="en-US" sz="1200" dirty="0" err="1"/>
              <a:t>RpoA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4341260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F7B6DD4-4DA9-C0C7-BB9B-17E17E8C97AB}"/>
              </a:ext>
            </a:extLst>
          </p:cNvPr>
          <p:cNvSpPr txBox="1"/>
          <p:nvPr/>
        </p:nvSpPr>
        <p:spPr>
          <a:xfrm>
            <a:off x="236020" y="420135"/>
            <a:ext cx="23899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82CA560-AD6E-D683-4991-1D77BFEBCB4E}"/>
              </a:ext>
            </a:extLst>
          </p:cNvPr>
          <p:cNvSpPr txBox="1"/>
          <p:nvPr/>
        </p:nvSpPr>
        <p:spPr>
          <a:xfrm>
            <a:off x="853012" y="503404"/>
            <a:ext cx="914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Rep 1 HALO</a:t>
            </a:r>
          </a:p>
        </p:txBody>
      </p:sp>
      <p:pic>
        <p:nvPicPr>
          <p:cNvPr id="17" name="Picture 16" descr="A picture containing black and white, monochrome, winter, snow&#10;&#10;Description automatically generated">
            <a:extLst>
              <a:ext uri="{FF2B5EF4-FFF2-40B4-BE49-F238E27FC236}">
                <a16:creationId xmlns:a16="http://schemas.microsoft.com/office/drawing/2014/main" id="{B92FAB28-BFFE-9FC6-BEFE-44D80B628D2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38735" y="1187634"/>
            <a:ext cx="3392067" cy="226137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Picture 18" descr="A picture containing black and white, monochrome&#10;&#10;Description automatically generated">
            <a:extLst>
              <a:ext uri="{FF2B5EF4-FFF2-40B4-BE49-F238E27FC236}">
                <a16:creationId xmlns:a16="http://schemas.microsoft.com/office/drawing/2014/main" id="{54D7949B-A5D8-2876-8B0A-DAB3C8528F5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1873" y="1204055"/>
            <a:ext cx="3392067" cy="226137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" name="Picture 20" descr="A picture containing black and white, window, monochrome&#10;&#10;Description automatically generated">
            <a:extLst>
              <a:ext uri="{FF2B5EF4-FFF2-40B4-BE49-F238E27FC236}">
                <a16:creationId xmlns:a16="http://schemas.microsoft.com/office/drawing/2014/main" id="{EEE91C96-8EC7-41FD-3F65-0AA12483B805}"/>
              </a:ext>
            </a:extLst>
          </p:cNvPr>
          <p:cNvPicPr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3931920" y="4020888"/>
            <a:ext cx="3840480" cy="255871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" name="Picture 22" descr="A picture containing handwriting, text, drawing, black and white&#10;&#10;Description automatically generated">
            <a:extLst>
              <a:ext uri="{FF2B5EF4-FFF2-40B4-BE49-F238E27FC236}">
                <a16:creationId xmlns:a16="http://schemas.microsoft.com/office/drawing/2014/main" id="{1B6DE42D-EC23-6B6B-B272-DE29D0FC0ED4}"/>
              </a:ext>
            </a:extLst>
          </p:cNvPr>
          <p:cNvPicPr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27216" y="4034251"/>
            <a:ext cx="3840480" cy="255871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5" name="Picture 24" descr="A picture containing black and white, monochrome, monochrome photography, street&#10;&#10;Description automatically generated">
            <a:extLst>
              <a:ext uri="{FF2B5EF4-FFF2-40B4-BE49-F238E27FC236}">
                <a16:creationId xmlns:a16="http://schemas.microsoft.com/office/drawing/2014/main" id="{68817EE9-D34A-9905-A5DD-ED1DD1D1F4A9}"/>
              </a:ext>
            </a:extLst>
          </p:cNvPr>
          <p:cNvPicPr>
            <a:picLocks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401873" y="7218947"/>
            <a:ext cx="3630168" cy="241931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7" name="Picture 26" descr="A picture containing black and white, building, rectangle, window&#10;&#10;Description automatically generated">
            <a:extLst>
              <a:ext uri="{FF2B5EF4-FFF2-40B4-BE49-F238E27FC236}">
                <a16:creationId xmlns:a16="http://schemas.microsoft.com/office/drawing/2014/main" id="{0BCF6EC8-6E20-6F49-EBC3-B325F79B72C3}"/>
              </a:ext>
            </a:extLst>
          </p:cNvPr>
          <p:cNvPicPr>
            <a:picLocks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4142232" y="7218947"/>
            <a:ext cx="3630168" cy="241931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2D857E9B-E9E0-FB8C-16D0-F2C89805D3D8}"/>
              </a:ext>
            </a:extLst>
          </p:cNvPr>
          <p:cNvSpPr txBox="1"/>
          <p:nvPr/>
        </p:nvSpPr>
        <p:spPr>
          <a:xfrm>
            <a:off x="4460672" y="485454"/>
            <a:ext cx="216872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Rep 1 </a:t>
            </a:r>
          </a:p>
          <a:p>
            <a:r>
              <a:rPr lang="en-US" dirty="0"/>
              <a:t>EtBr (Total protein)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CCDAA113-8FB4-4BA0-8059-B039CC43575A}"/>
              </a:ext>
            </a:extLst>
          </p:cNvPr>
          <p:cNvSpPr txBox="1"/>
          <p:nvPr/>
        </p:nvSpPr>
        <p:spPr>
          <a:xfrm>
            <a:off x="853012" y="3431006"/>
            <a:ext cx="914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Rep 2 HALO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7B5821D1-9BF9-87A8-6143-A792125A9A4A}"/>
              </a:ext>
            </a:extLst>
          </p:cNvPr>
          <p:cNvSpPr txBox="1"/>
          <p:nvPr/>
        </p:nvSpPr>
        <p:spPr>
          <a:xfrm>
            <a:off x="4460672" y="3413056"/>
            <a:ext cx="216872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Rep 2 </a:t>
            </a:r>
          </a:p>
          <a:p>
            <a:r>
              <a:rPr lang="en-US" dirty="0"/>
              <a:t>EtBr (Total protein)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16A05F8E-6B96-E6E5-7E82-CD34CEA89BA6}"/>
              </a:ext>
            </a:extLst>
          </p:cNvPr>
          <p:cNvSpPr txBox="1"/>
          <p:nvPr/>
        </p:nvSpPr>
        <p:spPr>
          <a:xfrm>
            <a:off x="853012" y="6609712"/>
            <a:ext cx="914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Rep 3 HALO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5D8038F5-6B91-87E5-C90E-D4E88DD52D14}"/>
              </a:ext>
            </a:extLst>
          </p:cNvPr>
          <p:cNvSpPr txBox="1"/>
          <p:nvPr/>
        </p:nvSpPr>
        <p:spPr>
          <a:xfrm>
            <a:off x="4460672" y="6591762"/>
            <a:ext cx="216872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Rep 3 </a:t>
            </a:r>
          </a:p>
          <a:p>
            <a:r>
              <a:rPr lang="en-US" dirty="0"/>
              <a:t>EtBr (Total protein)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C1702787-C9D9-6621-6BDF-7AD5BA77503C}"/>
              </a:ext>
            </a:extLst>
          </p:cNvPr>
          <p:cNvSpPr txBox="1"/>
          <p:nvPr/>
        </p:nvSpPr>
        <p:spPr>
          <a:xfrm>
            <a:off x="-177714" y="1993171"/>
            <a:ext cx="10307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/>
              <a:t>FL</a:t>
            </a:r>
            <a:endParaRPr lang="en-US" sz="1200" baseline="-25000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D0812533-6247-FFDD-62A2-7F5210BF5C4C}"/>
              </a:ext>
            </a:extLst>
          </p:cNvPr>
          <p:cNvSpPr txBox="1"/>
          <p:nvPr/>
        </p:nvSpPr>
        <p:spPr>
          <a:xfrm>
            <a:off x="-113490" y="2174442"/>
            <a:ext cx="10307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/>
              <a:t>cleaved</a:t>
            </a:r>
            <a:endParaRPr lang="en-US" sz="1200" baseline="-25000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8F5B23EA-2034-8E03-D588-5AC85EAC0595}"/>
              </a:ext>
            </a:extLst>
          </p:cNvPr>
          <p:cNvSpPr txBox="1"/>
          <p:nvPr/>
        </p:nvSpPr>
        <p:spPr>
          <a:xfrm>
            <a:off x="303871" y="1888021"/>
            <a:ext cx="9698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/>
              <a:t>M</a:t>
            </a:r>
            <a:endParaRPr lang="en-US" sz="1200" baseline="-2500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7A06526F-1A44-FE2D-4173-304C3E36196A}"/>
              </a:ext>
            </a:extLst>
          </p:cNvPr>
          <p:cNvSpPr txBox="1"/>
          <p:nvPr/>
        </p:nvSpPr>
        <p:spPr>
          <a:xfrm>
            <a:off x="-426550" y="5075745"/>
            <a:ext cx="10307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/>
              <a:t>FL</a:t>
            </a:r>
            <a:endParaRPr lang="en-US" sz="1200" baseline="-250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6F1533E2-5A28-8A05-630C-B88AC1869E91}"/>
              </a:ext>
            </a:extLst>
          </p:cNvPr>
          <p:cNvSpPr txBox="1"/>
          <p:nvPr/>
        </p:nvSpPr>
        <p:spPr>
          <a:xfrm>
            <a:off x="-362326" y="5214244"/>
            <a:ext cx="10307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/>
              <a:t>cleaved</a:t>
            </a:r>
            <a:endParaRPr lang="en-US" sz="1200" baseline="-25000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0DE3EC94-B5A2-9A9C-1F14-4A7B9DBC344F}"/>
              </a:ext>
            </a:extLst>
          </p:cNvPr>
          <p:cNvSpPr txBox="1"/>
          <p:nvPr/>
        </p:nvSpPr>
        <p:spPr>
          <a:xfrm>
            <a:off x="23885" y="4918402"/>
            <a:ext cx="9698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/>
              <a:t>M</a:t>
            </a:r>
            <a:endParaRPr lang="en-US" sz="1200" baseline="-2500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9C889CD2-8E76-BAE2-F75F-CEF954A1EAB4}"/>
              </a:ext>
            </a:extLst>
          </p:cNvPr>
          <p:cNvSpPr txBox="1"/>
          <p:nvPr/>
        </p:nvSpPr>
        <p:spPr>
          <a:xfrm>
            <a:off x="-241938" y="8222572"/>
            <a:ext cx="10307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/>
              <a:t>FL</a:t>
            </a:r>
            <a:endParaRPr lang="en-US" sz="1200" baseline="-250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FF8C4A94-6247-1835-0500-50F16BB6E00A}"/>
              </a:ext>
            </a:extLst>
          </p:cNvPr>
          <p:cNvSpPr txBox="1"/>
          <p:nvPr/>
        </p:nvSpPr>
        <p:spPr>
          <a:xfrm>
            <a:off x="-177714" y="8361071"/>
            <a:ext cx="10307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/>
              <a:t>cleaved</a:t>
            </a:r>
            <a:endParaRPr lang="en-US" sz="1200" baseline="-250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B71CE0D9-D18F-3081-6FCD-C2D9DF288B5D}"/>
              </a:ext>
            </a:extLst>
          </p:cNvPr>
          <p:cNvSpPr txBox="1"/>
          <p:nvPr/>
        </p:nvSpPr>
        <p:spPr>
          <a:xfrm>
            <a:off x="236020" y="8081602"/>
            <a:ext cx="9698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/>
              <a:t>M</a:t>
            </a:r>
            <a:endParaRPr lang="en-US" sz="1200" baseline="-25000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F3C78CFA-2A50-EC28-5EBD-5DCE8B077035}"/>
              </a:ext>
            </a:extLst>
          </p:cNvPr>
          <p:cNvSpPr txBox="1"/>
          <p:nvPr/>
        </p:nvSpPr>
        <p:spPr>
          <a:xfrm>
            <a:off x="3990044" y="8046744"/>
            <a:ext cx="9698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/>
              <a:t>M</a:t>
            </a:r>
            <a:endParaRPr lang="en-US" sz="1200" baseline="-250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9E22BE78-53F3-169E-C45E-495FEA7FD889}"/>
              </a:ext>
            </a:extLst>
          </p:cNvPr>
          <p:cNvSpPr txBox="1"/>
          <p:nvPr/>
        </p:nvSpPr>
        <p:spPr>
          <a:xfrm>
            <a:off x="3840481" y="4798746"/>
            <a:ext cx="9698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/>
              <a:t>M</a:t>
            </a:r>
            <a:endParaRPr lang="en-US" sz="1200" baseline="-250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D3905147-65F1-2ACD-2F35-BA5A6BD88871}"/>
              </a:ext>
            </a:extLst>
          </p:cNvPr>
          <p:cNvSpPr txBox="1"/>
          <p:nvPr/>
        </p:nvSpPr>
        <p:spPr>
          <a:xfrm>
            <a:off x="3824386" y="1854671"/>
            <a:ext cx="9698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/>
              <a:t>M</a:t>
            </a:r>
            <a:endParaRPr lang="en-US" sz="1200" baseline="-25000" dirty="0"/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12E0A3E1-28F2-B7D2-94D1-055DE583B3E6}"/>
              </a:ext>
            </a:extLst>
          </p:cNvPr>
          <p:cNvSpPr/>
          <p:nvPr/>
        </p:nvSpPr>
        <p:spPr>
          <a:xfrm>
            <a:off x="917236" y="1925859"/>
            <a:ext cx="2314914" cy="562953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B1AB7085-790D-75C5-6617-72CB7D9EF694}"/>
              </a:ext>
            </a:extLst>
          </p:cNvPr>
          <p:cNvSpPr/>
          <p:nvPr/>
        </p:nvSpPr>
        <p:spPr>
          <a:xfrm>
            <a:off x="4460672" y="1914500"/>
            <a:ext cx="2308428" cy="562953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C45EE911-D9E0-409B-EC3F-8FF127D95D3D}"/>
              </a:ext>
            </a:extLst>
          </p:cNvPr>
          <p:cNvSpPr/>
          <p:nvPr/>
        </p:nvSpPr>
        <p:spPr>
          <a:xfrm>
            <a:off x="1118835" y="5041980"/>
            <a:ext cx="2314914" cy="562953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4BB73996-9A18-321B-81BA-2B08281BF946}"/>
              </a:ext>
            </a:extLst>
          </p:cNvPr>
          <p:cNvSpPr/>
          <p:nvPr/>
        </p:nvSpPr>
        <p:spPr>
          <a:xfrm>
            <a:off x="5022374" y="5030621"/>
            <a:ext cx="2308428" cy="562953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1CC276DD-F591-7D5E-8CC5-3E99FB4AF4CE}"/>
              </a:ext>
            </a:extLst>
          </p:cNvPr>
          <p:cNvSpPr/>
          <p:nvPr/>
        </p:nvSpPr>
        <p:spPr>
          <a:xfrm>
            <a:off x="788787" y="8133586"/>
            <a:ext cx="2458311" cy="64633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3F715893-F209-2C50-EA6A-D9CAD23996DD}"/>
              </a:ext>
            </a:extLst>
          </p:cNvPr>
          <p:cNvSpPr/>
          <p:nvPr/>
        </p:nvSpPr>
        <p:spPr>
          <a:xfrm>
            <a:off x="4692326" y="8122227"/>
            <a:ext cx="2451423" cy="64633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874838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B15D278-6728-0F7B-2DD4-E4DA3DB380EC}"/>
              </a:ext>
            </a:extLst>
          </p:cNvPr>
          <p:cNvSpPr txBox="1"/>
          <p:nvPr/>
        </p:nvSpPr>
        <p:spPr>
          <a:xfrm>
            <a:off x="956952" y="860295"/>
            <a:ext cx="23899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1C</a:t>
            </a:r>
          </a:p>
        </p:txBody>
      </p:sp>
      <p:pic>
        <p:nvPicPr>
          <p:cNvPr id="8" name="Picture 7" descr="A picture containing white, fog, black and white, monochrome&#10;&#10;Description automatically generated">
            <a:extLst>
              <a:ext uri="{FF2B5EF4-FFF2-40B4-BE49-F238E27FC236}">
                <a16:creationId xmlns:a16="http://schemas.microsoft.com/office/drawing/2014/main" id="{AB468B83-CE20-7EC7-C2BD-BE1768B532D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678" y="1653646"/>
            <a:ext cx="6920706" cy="461380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11C9CB75-FEDC-902C-8AEC-F54A51D8EAEA}"/>
              </a:ext>
            </a:extLst>
          </p:cNvPr>
          <p:cNvSpPr/>
          <p:nvPr/>
        </p:nvSpPr>
        <p:spPr>
          <a:xfrm>
            <a:off x="2381325" y="3605267"/>
            <a:ext cx="732914" cy="459986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FB4DAC13-2974-56DE-8D8F-18E673D555C6}"/>
              </a:ext>
            </a:extLst>
          </p:cNvPr>
          <p:cNvSpPr/>
          <p:nvPr/>
        </p:nvSpPr>
        <p:spPr>
          <a:xfrm>
            <a:off x="3156462" y="3605267"/>
            <a:ext cx="732913" cy="459986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16F9DE8-DE36-FECD-09DD-A6E0FAC1FE2F}"/>
              </a:ext>
            </a:extLst>
          </p:cNvPr>
          <p:cNvSpPr txBox="1"/>
          <p:nvPr/>
        </p:nvSpPr>
        <p:spPr>
          <a:xfrm>
            <a:off x="2034226" y="2859643"/>
            <a:ext cx="914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C900F47-3600-EC15-C964-88BF5B20B724}"/>
              </a:ext>
            </a:extLst>
          </p:cNvPr>
          <p:cNvSpPr txBox="1"/>
          <p:nvPr/>
        </p:nvSpPr>
        <p:spPr>
          <a:xfrm>
            <a:off x="2441986" y="3235090"/>
            <a:ext cx="914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Rep 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AECF8C2-F9BD-A295-93C1-66F6EC1E6096}"/>
              </a:ext>
            </a:extLst>
          </p:cNvPr>
          <p:cNvSpPr txBox="1"/>
          <p:nvPr/>
        </p:nvSpPr>
        <p:spPr>
          <a:xfrm>
            <a:off x="3156462" y="3221874"/>
            <a:ext cx="914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Rep 2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604BD28-E0E7-3580-9F0E-DC70A515B370}"/>
              </a:ext>
            </a:extLst>
          </p:cNvPr>
          <p:cNvSpPr txBox="1"/>
          <p:nvPr/>
        </p:nvSpPr>
        <p:spPr>
          <a:xfrm>
            <a:off x="966351" y="3581541"/>
            <a:ext cx="14615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 err="1"/>
              <a:t>RpoA</a:t>
            </a:r>
            <a:endParaRPr lang="en-US" sz="1200" dirty="0"/>
          </a:p>
          <a:p>
            <a:pPr algn="r"/>
            <a:r>
              <a:rPr lang="en-US" sz="1200" dirty="0"/>
              <a:t>VqmA</a:t>
            </a:r>
            <a:r>
              <a:rPr lang="en-US" sz="1200" baseline="-25000" dirty="0"/>
              <a:t>882</a:t>
            </a:r>
            <a:r>
              <a:rPr lang="en-US" sz="1200" dirty="0"/>
              <a:t>-3XFLAG</a:t>
            </a:r>
          </a:p>
        </p:txBody>
      </p:sp>
      <p:sp>
        <p:nvSpPr>
          <p:cNvPr id="17" name="Cross 16">
            <a:extLst>
              <a:ext uri="{FF2B5EF4-FFF2-40B4-BE49-F238E27FC236}">
                <a16:creationId xmlns:a16="http://schemas.microsoft.com/office/drawing/2014/main" id="{55E041C1-EB63-9FE3-FD8A-900EC4EE985F}"/>
              </a:ext>
            </a:extLst>
          </p:cNvPr>
          <p:cNvSpPr/>
          <p:nvPr/>
        </p:nvSpPr>
        <p:spPr>
          <a:xfrm rot="18900000">
            <a:off x="4045039" y="3044310"/>
            <a:ext cx="582709" cy="582709"/>
          </a:xfrm>
          <a:prstGeom prst="plus">
            <a:avLst>
              <a:gd name="adj" fmla="val 50000"/>
            </a:avLst>
          </a:prstGeom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52731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2ff60116-7431-425d-b5af-077d7791bda4}" enabled="0" method="" siteId="{2ff60116-7431-425d-b5af-077d7791bda4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06</TotalTime>
  <Words>103</Words>
  <Application>Microsoft Office PowerPoint</Application>
  <PresentationFormat>Custom</PresentationFormat>
  <Paragraphs>6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stin Silpe</dc:creator>
  <cp:lastModifiedBy>Justin Silpe</cp:lastModifiedBy>
  <cp:revision>2</cp:revision>
  <dcterms:created xsi:type="dcterms:W3CDTF">2023-05-30T16:14:38Z</dcterms:created>
  <dcterms:modified xsi:type="dcterms:W3CDTF">2023-07-10T14:52:25Z</dcterms:modified>
</cp:coreProperties>
</file>